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A20A18-B2CF-4C3A-A77F-1DE947C1A4B6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E1CF7E-38E4-42D5-AD8B-2E8CEA7EEAE5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E272D-194A-40FE-A002-AB5083792B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CFD24-20F7-4170-B945-A2ED12695D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D5576-D5E5-4AE2-B635-E5E0CB21FF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4903C-765B-4863-B8E0-8A263051C6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4B9E4-EF12-4660-B2BD-FB2ADEBD3F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9C76D-C735-4DB5-ADB0-440F779DEB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DDE52-ED63-4055-9385-512A163E20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FDF3E-845A-4EE6-9EBE-B39F910EA3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2B55B-4198-4BAA-844F-25F68E01CE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A4999B-D1A3-4DB9-9CC2-8118C33E49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322D7-46A9-4CB7-B2EC-DED4FC37AF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EED2C-E464-41B4-9644-CAC8F8E3EE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08285A-9EDC-4294-B436-81DA343DF87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187280" y="620640"/>
          <a:ext cx="6985080" cy="6048360"/>
        </p:xfrm>
        <a:graphic>
          <a:graphicData uri="http://schemas.openxmlformats.org/drawingml/2006/table">
            <a:tbl>
              <a:tblPr/>
              <a:tblGrid>
                <a:gridCol w="2329200"/>
                <a:gridCol w="2327040"/>
                <a:gridCol w="2328840"/>
              </a:tblGrid>
              <a:tr h="33660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Antibody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Company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Cat .Numbe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3351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use anti-GRP78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ca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122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3624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use anti-GADD153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ca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114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366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bit anti-cleaved PARP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 signall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351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use anti-pIF2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ca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321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5889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rabbit anti-cleavage casp 3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 signall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6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348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bit anti-AK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 signall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2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366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bit anti-pAK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 signall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5889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use anti- phospho-p70 S6 Kinas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 signall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2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587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bit  anti-p70 S6 Kinas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 signall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MX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2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5871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bit anti-phospho-S6 Ribosomal Protei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 signall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366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bbit anti- 4EBP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ell signall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4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366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use anti-acti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ca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32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3348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use anti-alpha tubuli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ca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113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33660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use anti-IF2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ca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53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49" name="TextBox 10"/>
          <p:cNvSpPr/>
          <p:nvPr/>
        </p:nvSpPr>
        <p:spPr>
          <a:xfrm>
            <a:off x="3963240" y="250920"/>
            <a:ext cx="1179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800" spc="-1" strike="noStrike">
                <a:solidFill>
                  <a:srgbClr val="000000"/>
                </a:solidFill>
                <a:latin typeface="Calibri"/>
              </a:rPr>
              <a:t>Antibodi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9"/>
          <p:cNvSpPr/>
          <p:nvPr/>
        </p:nvSpPr>
        <p:spPr>
          <a:xfrm>
            <a:off x="179280" y="115920"/>
            <a:ext cx="197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. Fig.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8T18:30:40Z</dcterms:created>
  <dc:creator>azteca</dc:creator>
  <dc:description/>
  <dc:language>en-US</dc:language>
  <cp:lastModifiedBy>Alberto C</cp:lastModifiedBy>
  <dcterms:modified xsi:type="dcterms:W3CDTF">2012-03-05T14:32:18Z</dcterms:modified>
  <cp:revision>4</cp:revision>
  <dc:subject/>
  <dc:title>Slide 1</dc:title>
</cp:coreProperties>
</file>